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5" r:id="rId2"/>
    <p:sldId id="286" r:id="rId3"/>
    <p:sldId id="284" r:id="rId4"/>
    <p:sldId id="306" r:id="rId5"/>
    <p:sldId id="289" r:id="rId6"/>
    <p:sldId id="256" r:id="rId7"/>
    <p:sldId id="282" r:id="rId8"/>
    <p:sldId id="283" r:id="rId9"/>
    <p:sldId id="290" r:id="rId10"/>
    <p:sldId id="257" r:id="rId11"/>
    <p:sldId id="287" r:id="rId12"/>
    <p:sldId id="258" r:id="rId13"/>
    <p:sldId id="291" r:id="rId14"/>
    <p:sldId id="292" r:id="rId15"/>
    <p:sldId id="293" r:id="rId16"/>
    <p:sldId id="294" r:id="rId17"/>
    <p:sldId id="295" r:id="rId18"/>
    <p:sldId id="296" r:id="rId19"/>
    <p:sldId id="297" r:id="rId20"/>
    <p:sldId id="298" r:id="rId21"/>
    <p:sldId id="299" r:id="rId22"/>
    <p:sldId id="300" r:id="rId23"/>
    <p:sldId id="301" r:id="rId24"/>
    <p:sldId id="302" r:id="rId25"/>
    <p:sldId id="304" r:id="rId26"/>
    <p:sldId id="305" r:id="rId2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61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86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526B25F-A89A-7122-541E-CD12615DB7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C3AF7D1C-2E04-D543-EBCC-92E62B4B6F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D4D3C2D-6540-E28B-0498-AA9C3F521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8A15877-F34F-F68A-69EB-AE39C33FE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DBB5F19-92A9-8A7F-32B0-3699582C5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1679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BCD2C8A-AD74-20AB-2B58-8E4D4A8123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A2F2C9D-2F30-886A-7827-C06C10CD7F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23B08A3-07D7-EE42-3E90-89D91B9AF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233DA8C-3176-6033-F184-0EC4DDBD5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D23EA34-CB25-DF20-D1E9-1D04C5A9A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2617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85E3427F-F5CD-EBE1-2881-B20FDA65A8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9AFD699-3FF1-73BD-13A2-7929AAD2D6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DEF78D4-208E-3339-422F-23685FCCD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C17BE74-472A-0D60-9017-2AAC7E335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3CD68D1-0D95-C9D6-7956-69EBE6BED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7235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1C8EAFE-B489-6CCB-5D61-1C909ACB39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88D2C26-24D6-ABFE-DABF-732DFB9553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8A04D2D-D5C2-92DA-EA47-C77B730B6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8E41EAF-978F-F293-2171-E3717D48C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667D859-33B0-65E3-2361-82A29056A2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1883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3470973-048D-9F81-14B5-3D8AE5E972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265E8DE-A679-9FF8-BC62-ABFD7A74D4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6F8DC22-F12E-D4FF-4E0B-CD771EBFE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1B6D4D4-757F-FEEA-894B-492601838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D5EF506-4BE6-579A-65D3-C6D175334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9285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9E2C888-D271-657B-379E-77AFCF28B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403590C-3F8F-EAD3-0C6E-848BF2D564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56C9801-5BD8-BAF2-09CE-ABE134CA4F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2F5E16F-60BD-3CB4-33EE-EEAF34E6D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D94F0A7-A3EC-8A46-192E-7B4EBA279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1C71DD8-DD62-7639-670A-39AFA5D77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595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64C0F91-E369-8589-EDAF-F8AC43E2C8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55FE8C1-0ECA-4A6B-7F0C-D04204F05C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4A4EC49-D1D9-98DC-50B3-67EA3B52C6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616A290-E43E-59F5-92F7-020356DB63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2F6C0F4-57CE-6691-0B4A-9EDA726ECA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547A370-57F6-355D-C183-48FFC2E0F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7B488DD-289F-78B5-B5A5-D9ABB8A36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A7F7E5C0-E631-7ED3-9672-37A157F732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1183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442CFD0-C55C-E7A4-1F8D-5505EBDED0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7E32AB8-551C-3D92-635B-0D26CCD4B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67461443-84DC-39B9-9E2A-7291BC49FC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A7B2766-14A8-7837-7CB0-D7F86E64E2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3632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37242644-8332-7491-AB82-335BE60EA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089E2244-D490-4565-20D6-0ECF4E492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5CEEBCC-B945-174E-97ED-F892F25C4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8827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9B3CD98-825C-1B57-FA1F-FB1B9B7389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C59779D-4CDF-8CE5-3454-95F7874947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B4FE608-737D-699D-3080-0188D9B8CC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7F77B9E-8405-BCBD-3194-E50259039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C22A3B1-0088-5101-2BB0-0B3C413CC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413FA82-75C4-2629-121E-7E5B40CFE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4487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55A4F3E-D532-7171-2E8F-34ACAB9A21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426F346-16C0-E8E5-FC82-480B05B75C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E21C540-1ECB-D220-36C9-5C850AEA88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EB45B47-EB2E-E023-51E9-1050690D4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DE29C98-55C4-B9E6-8F51-83440F616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CBA6248-C14F-BA82-674B-3D868079B2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2965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A6B83FFA-A798-DCA0-A6DC-0CFFC1C6B4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DE389C3-53D0-704E-8B32-ED0E8065F0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D4AAE8A-80CA-4BDF-6FD8-5158C0921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CB3A61-5B64-4ABC-AAE5-92610DFFA4B8}" type="datetimeFigureOut">
              <a:rPr lang="ko-KR" altLang="en-US" smtClean="0"/>
              <a:t>2026-05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22D1150-A89D-BC43-A921-9525EA9183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3B23E04-4759-9D38-B05F-DD06FE5183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F2524-E93F-4FCC-8BA7-980F41927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9082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346942" y="1975690"/>
            <a:ext cx="11514135" cy="2923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7246938" algn="l"/>
              </a:tabLst>
            </a:pPr>
            <a:r>
              <a:rPr lang="en-US" altLang="ko-KR" sz="3200" b="1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orting Information</a:t>
            </a: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7246938" algn="l"/>
              </a:tabLst>
            </a:pPr>
            <a:endParaRPr lang="en-US" altLang="ko-KR" sz="3200" b="1" dirty="0">
              <a:latin typeface="Palatino Linotype" panose="0204050205050503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7246938" algn="l"/>
              </a:tabLst>
            </a:pPr>
            <a:endParaRPr lang="en-US" altLang="ko-KR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7246938" algn="l"/>
              </a:tabLst>
            </a:pPr>
            <a:r>
              <a:rPr lang="en-US" altLang="ko-KR" sz="28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Radiolysis Derivatives from p-Coumaric Acid via Gamma </a:t>
            </a: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7246938" algn="l"/>
              </a:tabLst>
            </a:pPr>
            <a:r>
              <a:rPr lang="en-US" altLang="ko-KR" sz="28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Irradiation and Their Anti-Inflammatory Activities</a:t>
            </a: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7246938" algn="l"/>
              </a:tabLst>
            </a:pPr>
            <a:endParaRPr lang="en-US" altLang="ko-KR" dirty="0">
              <a:latin typeface="Palatino Linotype" panose="02040502050505030304" pitchFamily="18" charset="0"/>
            </a:endParaRP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7246938" algn="l"/>
              </a:tabLst>
            </a:pPr>
            <a:r>
              <a:rPr lang="en-US" altLang="ko-KR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h-</a:t>
            </a:r>
            <a:r>
              <a:rPr lang="en-US" altLang="ko-KR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um</a:t>
            </a:r>
            <a:r>
              <a:rPr lang="en-US" altLang="ko-KR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Han, Ha-Yeon Song , Gyeong Han Jeong , Euna Choi , </a:t>
            </a:r>
            <a:r>
              <a:rPr lang="en-US" altLang="ko-KR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YuJung</a:t>
            </a:r>
            <a:r>
              <a:rPr lang="en-US" altLang="ko-KR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in , </a:t>
            </a: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7246938" algn="l"/>
              </a:tabLst>
            </a:pPr>
            <a:r>
              <a:rPr lang="en-US" altLang="ko-KR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o-</a:t>
            </a:r>
            <a:r>
              <a:rPr lang="en-US" sz="18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Yeon</a:t>
            </a:r>
            <a:r>
              <a:rPr lang="en-US" altLang="ko-KR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Kim </a:t>
            </a:r>
            <a:r>
              <a:rPr lang="en-US" altLang="ko-KR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ko-KR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o-Yeun Woo , Chang Hyun Jin , Eui-Baek Byun , </a:t>
            </a:r>
            <a:r>
              <a:rPr lang="en-US" altLang="ko-KR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young</a:t>
            </a:r>
            <a:r>
              <a:rPr lang="en-US" altLang="ko-KR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Woo Bai </a:t>
            </a:r>
            <a:endParaRPr lang="en-US" altLang="ko-KR" baseline="30000" dirty="0">
              <a:solidFill>
                <a:srgbClr val="000000"/>
              </a:solidFill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56741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910290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-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3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 HSQC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5939" y="12032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95493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910290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9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-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3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 HMBC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5939" y="24064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594059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910294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0. 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ECD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03112" y="1959736"/>
            <a:ext cx="4785775" cy="29385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054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68553"/>
            <a:ext cx="1151626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1. 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RESIMS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b="1" kern="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그림 2"/>
          <p:cNvPicPr/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7134" y="322849"/>
            <a:ext cx="9777730" cy="551561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0946249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68553"/>
            <a:ext cx="11516263" cy="2970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2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 NMR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968187" y="-551330"/>
            <a:ext cx="141284" cy="79607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5939" y="0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147351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909959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3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3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 NMR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0286" y="0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88276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08393"/>
            <a:ext cx="11516263" cy="2970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4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-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 COSY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5939" y="-36096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620144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08393"/>
            <a:ext cx="11516263" cy="2970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5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-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 NOESY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5939" y="-41370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721238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910290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6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-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3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 HSQC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5939" y="16942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713136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910290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7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-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3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 HMBC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5939" y="0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09290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>
            <a:off x="1778017" y="557495"/>
            <a:ext cx="863816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ONTENTS</a:t>
            </a:r>
          </a:p>
        </p:txBody>
      </p:sp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3308338"/>
              </p:ext>
            </p:extLst>
          </p:nvPr>
        </p:nvGraphicFramePr>
        <p:xfrm>
          <a:off x="654529" y="1253553"/>
          <a:ext cx="10901745" cy="51206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9954">
                  <a:extLst>
                    <a:ext uri="{9D8B030D-6E8A-4147-A177-3AD203B41FA5}">
                      <a16:colId xmlns:a16="http://schemas.microsoft.com/office/drawing/2014/main" val="3282660625"/>
                    </a:ext>
                  </a:extLst>
                </a:gridCol>
                <a:gridCol w="9661791">
                  <a:extLst>
                    <a:ext uri="{9D8B030D-6E8A-4147-A177-3AD203B41FA5}">
                      <a16:colId xmlns:a16="http://schemas.microsoft.com/office/drawing/2014/main" val="1741496467"/>
                    </a:ext>
                  </a:extLst>
                </a:gridCol>
              </a:tblGrid>
              <a:tr h="1885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1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MS Mincho"/>
                          <a:cs typeface="Times New Roman" panose="02020603050405020304" pitchFamily="18" charset="0"/>
                        </a:rPr>
                        <a:t>HPLC profiles of </a:t>
                      </a:r>
                      <a:r>
                        <a:rPr lang="en-US" altLang="ko-KR" sz="1400" i="1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MS Mincho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MS Mincho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MS Mincho"/>
                          <a:cs typeface="Times New Roman" panose="02020603050405020304" pitchFamily="18" charset="0"/>
                        </a:rPr>
                        <a:t>coumaric</a:t>
                      </a:r>
                      <a:r>
                        <a:rPr lang="ko-KR" altLang="en-US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MS Mincho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MS Mincho"/>
                          <a:cs typeface="Times New Roman" panose="02020603050405020304" pitchFamily="18" charset="0"/>
                        </a:rPr>
                        <a:t>acid</a:t>
                      </a:r>
                      <a:r>
                        <a:rPr lang="ko-KR" altLang="en-US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MS Mincho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MS Mincho"/>
                          <a:cs typeface="Times New Roman" panose="02020603050405020304" pitchFamily="18" charset="0"/>
                        </a:rPr>
                        <a:t> irradiated with the following doses: 20, 40, and 60</a:t>
                      </a:r>
                      <a:r>
                        <a:rPr lang="en-US" altLang="ko-KR" sz="14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MS Mincho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MS Mincho"/>
                          <a:cs typeface="Times New Roman" panose="02020603050405020304" pitchFamily="18" charset="0"/>
                        </a:rPr>
                        <a:t>kGy</a:t>
                      </a:r>
                      <a:r>
                        <a:rPr lang="en-US" altLang="ko-KR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MS Mincho"/>
                          <a:cs typeface="Times New Roman" panose="02020603050405020304" pitchFamily="18" charset="0"/>
                        </a:rPr>
                        <a:t>. </a:t>
                      </a:r>
                      <a:endParaRPr lang="ko-KR" sz="1400" b="1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09546588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Figure S2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1400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s of ibuprofen (IBF) on the cell viability of RAW 264.7 cells. 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66412784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3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RESIMS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b="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07426008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4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7246620" algn="l"/>
                        </a:tabLst>
                        <a:defRPr/>
                      </a:pPr>
                      <a:r>
                        <a:rPr lang="en-US" sz="1400" kern="100" baseline="300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sz="14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 NMR spectrum of 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lang="en-US" sz="14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	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75076856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5.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 NMR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82616202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6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-</a:t>
                      </a: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ko-KR" sz="1400" kern="100" baseline="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 COSY 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93769400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7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-</a:t>
                      </a: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ko-KR" sz="1400" kern="100" baseline="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 NOESY 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4408131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Figure S8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-</a:t>
                      </a: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 HSQC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46506883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Figure S9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-</a:t>
                      </a: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 HMBC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25637356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400" b="1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10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ECD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94463807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400" b="1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11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RESIMS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b="1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59333916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400" b="1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12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7246620" algn="l"/>
                        </a:tabLst>
                        <a:defRPr/>
                      </a:pPr>
                      <a:r>
                        <a:rPr lang="en-US" sz="1400" kern="100" baseline="300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sz="14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 NMR spectrum of 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lang="en-US" sz="14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	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32545359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400" b="1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13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 NMR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68480370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400" b="1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14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-</a:t>
                      </a: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ko-KR" sz="1400" kern="100" baseline="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 COSY 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06516153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400" b="1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15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-</a:t>
                      </a: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ko-KR" sz="1400" kern="100" baseline="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 NOESY 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71206810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400" b="1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16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-</a:t>
                      </a: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 HSQC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86255830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400" b="1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17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-</a:t>
                      </a: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 HMBC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6705497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18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ECD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82320674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19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7246620" algn="l"/>
                        </a:tabLst>
                        <a:defRPr/>
                      </a:pPr>
                      <a:r>
                        <a:rPr kumimoji="0" lang="en-US" altLang="ko-KR" sz="1400" b="0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RESIMS spectrum of compound </a:t>
                      </a:r>
                      <a:r>
                        <a:rPr kumimoji="0" lang="en-US" altLang="ko-KR" sz="1400" b="1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0" lang="en-US" altLang="ko-KR" sz="1400" b="0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kumimoji="0" lang="ko-KR" altLang="en-US" sz="1400" b="1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80799240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20.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7246620" algn="l"/>
                        </a:tabLst>
                        <a:defRPr/>
                      </a:pPr>
                      <a:r>
                        <a:rPr lang="en-US" sz="1400" kern="100" baseline="300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sz="14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 NMR spectrum of 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lang="en-US" sz="14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	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2540605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ure S21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 NMR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07473791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Figure S22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-</a:t>
                      </a: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ko-KR" sz="1400" kern="100" baseline="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 COSY 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95004406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Figure S23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-</a:t>
                      </a: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 HSQC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6725636"/>
                  </a:ext>
                </a:extLst>
              </a:tr>
              <a:tr h="188565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Figure S24.</a:t>
                      </a:r>
                      <a:endParaRPr lang="ko-KR" altLang="ko-KR" sz="1400" kern="100" dirty="0"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7246620" algn="l"/>
                        </a:tabLst>
                      </a:pP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H-</a:t>
                      </a:r>
                      <a:r>
                        <a:rPr lang="en-US" altLang="ko-KR" sz="140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</a:t>
                      </a:r>
                      <a:r>
                        <a:rPr lang="en-US" altLang="ko-KR" sz="140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C HMBC spectrum of compound </a:t>
                      </a:r>
                      <a:r>
                        <a:rPr lang="en-US" altLang="ko-KR" sz="1400" b="1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ko-KR" sz="1400" b="0" kern="100" dirty="0"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lang="ko-KR" sz="14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208543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7068916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910294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8. 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ECD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4450" y="2008509"/>
            <a:ext cx="4743099" cy="28409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3322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/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7135" y="331552"/>
            <a:ext cx="9777730" cy="551561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68553"/>
            <a:ext cx="1151626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9. 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RESIMS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b="1" kern="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984939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68553"/>
            <a:ext cx="11516263" cy="2970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0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 NMR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968187" y="-551330"/>
            <a:ext cx="141284" cy="79607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5844" y="27291"/>
            <a:ext cx="8496300" cy="6019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261076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909959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1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3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 NMR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4658" y="35168"/>
            <a:ext cx="8534400" cy="60274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250735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08393"/>
            <a:ext cx="11516263" cy="2970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2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-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 COSY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6599" y="60899"/>
            <a:ext cx="8519160" cy="5981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614970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910290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3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-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3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 HSQC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2609" y="40383"/>
            <a:ext cx="8526780" cy="6019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141717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910290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4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-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3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 HMBC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4039" y="43960"/>
            <a:ext cx="8503920" cy="6019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91377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68553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ko-KR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HPLC profiles of </a:t>
            </a:r>
            <a:r>
              <a:rPr lang="en-US" altLang="ko-KR" sz="1400" i="1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p</a:t>
            </a:r>
            <a:r>
              <a:rPr lang="en-US" altLang="ko-KR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-</a:t>
            </a:r>
            <a:r>
              <a:rPr lang="en-US" altLang="ko-KR" sz="1400" dirty="0" err="1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coumaric</a:t>
            </a:r>
            <a:r>
              <a:rPr lang="ko-KR" altLang="en-US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acid</a:t>
            </a:r>
            <a:r>
              <a:rPr lang="ko-KR" altLang="en-US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 irradiated with the following doses: 20, 40, and 60 </a:t>
            </a:r>
            <a:r>
              <a:rPr lang="en-US" altLang="ko-KR" sz="1400" dirty="0" err="1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kGy</a:t>
            </a:r>
            <a:r>
              <a:rPr lang="en-US" altLang="ko-KR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. Peak 1 is  </a:t>
            </a:r>
            <a:r>
              <a:rPr lang="en-US" altLang="ko-KR" sz="1400" i="1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p</a:t>
            </a:r>
            <a:r>
              <a:rPr lang="en-US" altLang="ko-KR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-</a:t>
            </a:r>
            <a:r>
              <a:rPr lang="en-US" altLang="ko-KR" sz="1400" dirty="0" err="1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coumaric</a:t>
            </a:r>
            <a:r>
              <a:rPr lang="ko-KR" altLang="en-US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acid</a:t>
            </a:r>
            <a:r>
              <a:rPr lang="ko-KR" altLang="en-US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  </a:t>
            </a:r>
            <a:r>
              <a:rPr lang="en-US" altLang="ko-KR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and other peaks are the radiolysis products of </a:t>
            </a:r>
            <a:r>
              <a:rPr lang="en-US" altLang="ko-KR" sz="1400" i="1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p</a:t>
            </a:r>
            <a:r>
              <a:rPr lang="en-US" altLang="ko-KR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-</a:t>
            </a:r>
            <a:r>
              <a:rPr lang="en-US" altLang="ko-KR" sz="1400" dirty="0" err="1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coumaric</a:t>
            </a:r>
            <a:r>
              <a:rPr lang="ko-KR" altLang="en-US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Palatino Linotype" panose="02040502050505030304" pitchFamily="18" charset="0"/>
                <a:ea typeface="MS Mincho"/>
                <a:cs typeface="Times New Roman" panose="02020603050405020304" pitchFamily="18" charset="0"/>
              </a:rPr>
              <a:t>acid.</a:t>
            </a:r>
            <a:endParaRPr lang="ko-KR" altLang="ko-KR" sz="1400" b="1" kern="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그룹 13"/>
          <p:cNvGrpSpPr/>
          <p:nvPr/>
        </p:nvGrpSpPr>
        <p:grpSpPr>
          <a:xfrm>
            <a:off x="431091" y="752672"/>
            <a:ext cx="10914000" cy="4755059"/>
            <a:chOff x="439800" y="918135"/>
            <a:chExt cx="10914000" cy="4755059"/>
          </a:xfrm>
        </p:grpSpPr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66E29BE9-17C7-466B-BC4E-BDACA3CD07A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53800" y="3347040"/>
              <a:ext cx="5400000" cy="2326154"/>
            </a:xfrm>
            <a:prstGeom prst="rect">
              <a:avLst/>
            </a:prstGeom>
          </p:spPr>
        </p:pic>
        <p:pic>
          <p:nvPicPr>
            <p:cNvPr id="16" name="그림 15">
              <a:extLst>
                <a:ext uri="{FF2B5EF4-FFF2-40B4-BE49-F238E27FC236}">
                  <a16:creationId xmlns:a16="http://schemas.microsoft.com/office/drawing/2014/main" id="{3899AAE3-ABEC-4F99-A48E-758A7BCA241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800" y="918135"/>
              <a:ext cx="5400000" cy="2326154"/>
            </a:xfrm>
            <a:prstGeom prst="rect">
              <a:avLst/>
            </a:prstGeom>
          </p:spPr>
        </p:pic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D0750D78-F5A8-4E5A-BA11-3584537541F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53800" y="918135"/>
              <a:ext cx="5400000" cy="2326154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8C157FC-C296-41E5-BBC4-25A94C0147BD}"/>
                </a:ext>
              </a:extLst>
            </p:cNvPr>
            <p:cNvSpPr txBox="1"/>
            <p:nvPr/>
          </p:nvSpPr>
          <p:spPr>
            <a:xfrm>
              <a:off x="5205225" y="944489"/>
              <a:ext cx="603050" cy="27699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n-US" altLang="ko-K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Gy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FCAD7C5-5F9F-4F40-A01E-AC44EC9EE31E}"/>
                </a:ext>
              </a:extLst>
            </p:cNvPr>
            <p:cNvSpPr txBox="1"/>
            <p:nvPr/>
          </p:nvSpPr>
          <p:spPr>
            <a:xfrm>
              <a:off x="10633185" y="953426"/>
              <a:ext cx="688009" cy="27699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altLang="ko-K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Gy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그림 30">
              <a:extLst>
                <a:ext uri="{FF2B5EF4-FFF2-40B4-BE49-F238E27FC236}">
                  <a16:creationId xmlns:a16="http://schemas.microsoft.com/office/drawing/2014/main" id="{6E65A1AF-B6C2-4DF9-A99D-2B4C695469C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760002" y="1637879"/>
              <a:ext cx="1447800" cy="952500"/>
            </a:xfrm>
            <a:prstGeom prst="rect">
              <a:avLst/>
            </a:prstGeom>
          </p:spPr>
        </p:pic>
        <p:pic>
          <p:nvPicPr>
            <p:cNvPr id="32" name="그림 31">
              <a:extLst>
                <a:ext uri="{FF2B5EF4-FFF2-40B4-BE49-F238E27FC236}">
                  <a16:creationId xmlns:a16="http://schemas.microsoft.com/office/drawing/2014/main" id="{42F800F1-D976-4365-863D-14E1E3EE975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800" y="3347040"/>
              <a:ext cx="5400000" cy="2326154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CDDCE78-DEC6-4561-AAAB-9214E4D93136}"/>
                </a:ext>
              </a:extLst>
            </p:cNvPr>
            <p:cNvSpPr txBox="1"/>
            <p:nvPr/>
          </p:nvSpPr>
          <p:spPr>
            <a:xfrm>
              <a:off x="5120266" y="3373167"/>
              <a:ext cx="688009" cy="27699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ko-K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Gy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753F8D0-9271-428A-8BD4-F21C75E593DA}"/>
                </a:ext>
              </a:extLst>
            </p:cNvPr>
            <p:cNvSpPr txBox="1"/>
            <p:nvPr/>
          </p:nvSpPr>
          <p:spPr>
            <a:xfrm>
              <a:off x="10633184" y="3382033"/>
              <a:ext cx="688009" cy="27699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0 </a:t>
              </a:r>
              <a:r>
                <a:rPr lang="en-US" altLang="ko-K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Gy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9A16216-9E60-4780-9DC2-82D0ED08EA1C}"/>
                </a:ext>
              </a:extLst>
            </p:cNvPr>
            <p:cNvSpPr txBox="1"/>
            <p:nvPr/>
          </p:nvSpPr>
          <p:spPr>
            <a:xfrm>
              <a:off x="6284405" y="4140152"/>
              <a:ext cx="26116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he radiolysis products of </a:t>
              </a:r>
              <a:r>
                <a:rPr lang="en-US" altLang="ko-KR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oumaric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acid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직선 연결선 35"/>
            <p:cNvCxnSpPr/>
            <p:nvPr/>
          </p:nvCxnSpPr>
          <p:spPr>
            <a:xfrm>
              <a:off x="6642043" y="4696894"/>
              <a:ext cx="1296000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직선 연결선 36"/>
            <p:cNvCxnSpPr/>
            <p:nvPr/>
          </p:nvCxnSpPr>
          <p:spPr>
            <a:xfrm>
              <a:off x="6642040" y="4696894"/>
              <a:ext cx="0" cy="25072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직선 연결선 37"/>
            <p:cNvCxnSpPr/>
            <p:nvPr/>
          </p:nvCxnSpPr>
          <p:spPr>
            <a:xfrm>
              <a:off x="7947930" y="4696894"/>
              <a:ext cx="0" cy="25072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직선 화살표 연결선 38"/>
            <p:cNvCxnSpPr/>
            <p:nvPr/>
          </p:nvCxnSpPr>
          <p:spPr>
            <a:xfrm flipV="1">
              <a:off x="7291685" y="4437749"/>
              <a:ext cx="3302" cy="250995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2269804" y="821029"/>
            <a:ext cx="5870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ak 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7769267" y="809804"/>
            <a:ext cx="5870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ak 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7925392" y="4656792"/>
            <a:ext cx="5870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ak 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364969" y="4504760"/>
            <a:ext cx="5870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ak 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80322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4816153" y="1807057"/>
            <a:ext cx="2559691" cy="2286884"/>
            <a:chOff x="5134560" y="1380337"/>
            <a:chExt cx="2559691" cy="2286884"/>
          </a:xfrm>
        </p:grpSpPr>
        <p:graphicFrame>
          <p:nvGraphicFramePr>
            <p:cNvPr id="4" name="개체 3">
              <a:extLst>
                <a:ext uri="{FF2B5EF4-FFF2-40B4-BE49-F238E27FC236}">
                  <a16:creationId xmlns:a16="http://schemas.microsoft.com/office/drawing/2014/main" id="{83583D71-04AE-5265-D7C5-5F7A5848100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38759377"/>
                </p:ext>
              </p:extLst>
            </p:nvPr>
          </p:nvGraphicFramePr>
          <p:xfrm>
            <a:off x="5134560" y="1380337"/>
            <a:ext cx="2559691" cy="21402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023339" imgH="2527921" progId="Prism8.Document">
                    <p:embed/>
                  </p:oleObj>
                </mc:Choice>
                <mc:Fallback>
                  <p:oleObj name="Prism 8" r:id="rId2" imgW="3023339" imgH="2527921" progId="Prism8.Document">
                    <p:embed/>
                    <p:pic>
                      <p:nvPicPr>
                        <p:cNvPr id="4" name="개체 3">
                          <a:extLst>
                            <a:ext uri="{FF2B5EF4-FFF2-40B4-BE49-F238E27FC236}">
                              <a16:creationId xmlns:a16="http://schemas.microsoft.com/office/drawing/2014/main" id="{83583D71-04AE-5265-D7C5-5F7A5848100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5134560" y="1380337"/>
                          <a:ext cx="2559691" cy="214024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6" name="직선 연결선 5">
              <a:extLst>
                <a:ext uri="{FF2B5EF4-FFF2-40B4-BE49-F238E27FC236}">
                  <a16:creationId xmlns:a16="http://schemas.microsoft.com/office/drawing/2014/main" id="{DFDD310E-4FF1-FD82-A973-F2953AD3E9A9}"/>
                </a:ext>
              </a:extLst>
            </p:cNvPr>
            <p:cNvCxnSpPr>
              <a:cxnSpLocks/>
            </p:cNvCxnSpPr>
            <p:nvPr/>
          </p:nvCxnSpPr>
          <p:spPr>
            <a:xfrm>
              <a:off x="6247599" y="3412087"/>
              <a:ext cx="939041" cy="0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CC35158-D4C0-AC73-9754-B28C3F3CF25D}"/>
                </a:ext>
              </a:extLst>
            </p:cNvPr>
            <p:cNvSpPr txBox="1"/>
            <p:nvPr/>
          </p:nvSpPr>
          <p:spPr>
            <a:xfrm>
              <a:off x="6414405" y="3412087"/>
              <a:ext cx="795676" cy="2551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>
                  <a:latin typeface="Arial" panose="020B0604020202020204" pitchFamily="34" charset="0"/>
                  <a:cs typeface="Arial" panose="020B0604020202020204" pitchFamily="34" charset="0"/>
                </a:rPr>
                <a:t>IBF</a:t>
              </a:r>
              <a:r>
                <a:rPr lang="ko-KR" altLang="en-US" sz="1058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58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ko-KR" altLang="en-US" sz="1058" dirty="0" err="1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058" dirty="0">
                  <a:latin typeface="Arial" panose="020B0604020202020204" pitchFamily="34" charset="0"/>
                  <a:cs typeface="Arial" panose="020B0604020202020204" pitchFamily="34" charset="0"/>
                </a:rPr>
                <a:t>M)</a:t>
              </a:r>
              <a:endParaRPr lang="ko-KR" altLang="en-US" sz="1058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직사각형 7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232536"/>
            <a:ext cx="11516263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cs typeface="맑은 고딕" panose="020B0503020000020004" pitchFamily="50" charset="-127"/>
              </a:rPr>
              <a:t>ure</a:t>
            </a: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2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ffects of ibuprofen (IBF) on the cell viability of RAW 264.7 cells. Cells were seeded in 96-well plates (5 ×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4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/well) and incubated overnight. Subsequently, the cells were treated with IBF at concentrations ranging from 20 to 100 </a:t>
            </a:r>
            <a:r>
              <a:rPr lang="en-US" altLang="ko-KR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incubated for 24 h. The control group (Con) was treated with 0.25% DMSO, serving as the vehicle control. Cell viability was analyzed by MTT assay. Data are presented as means ± SD (n = 3). Statistical analysis was performed using one-way ANOVA followed by Tukey’s post-hoc test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aseline="300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*</a:t>
            </a:r>
            <a:r>
              <a:rPr lang="en-US" altLang="ko-KR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5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represents statistical significance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b="1" kern="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85546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68553"/>
            <a:ext cx="1151626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RESIMS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b="1" kern="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그림 4"/>
          <p:cNvPicPr/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5844" y="331562"/>
            <a:ext cx="9777730" cy="551561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8323504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68553"/>
            <a:ext cx="11516263" cy="2970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 NMR spectrum of compound 1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968187" y="-551330"/>
            <a:ext cx="141284" cy="79607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5939" y="18790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89668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5909959"/>
            <a:ext cx="115162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tabLst>
                <a:tab pos="7246620" algn="l"/>
              </a:tabLs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3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 NMR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13" name="그림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5939" y="36096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266869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68553"/>
            <a:ext cx="11516263" cy="2970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-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 COSY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5939" y="-17306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66304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F6D58214-064A-991F-EA02-59CE60491385}"/>
              </a:ext>
            </a:extLst>
          </p:cNvPr>
          <p:cNvSpPr/>
          <p:nvPr/>
        </p:nvSpPr>
        <p:spPr>
          <a:xfrm>
            <a:off x="337868" y="6068553"/>
            <a:ext cx="11516263" cy="2970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-</a:t>
            </a:r>
            <a:r>
              <a:rPr lang="en-US" altLang="ko-KR" sz="1400" kern="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 NOESY spectrum of compound </a:t>
            </a:r>
            <a:r>
              <a:rPr lang="en-US" altLang="ko-KR" sz="1400" b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5939" y="-17306"/>
            <a:ext cx="8660119" cy="60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200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89</TotalTime>
  <Words>701</Words>
  <Application>Microsoft Office PowerPoint</Application>
  <PresentationFormat>Widescreen</PresentationFormat>
  <Paragraphs>91</Paragraphs>
  <Slides>2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1" baseType="lpstr">
      <vt:lpstr>맑은 고딕</vt:lpstr>
      <vt:lpstr>Arial</vt:lpstr>
      <vt:lpstr>Palatino Linotype</vt:lpstr>
      <vt:lpstr>Office 테마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지수</dc:creator>
  <cp:lastModifiedBy>MDPI</cp:lastModifiedBy>
  <cp:revision>60</cp:revision>
  <dcterms:created xsi:type="dcterms:W3CDTF">2022-08-05T06:35:21Z</dcterms:created>
  <dcterms:modified xsi:type="dcterms:W3CDTF">2026-05-12T06:28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Fasoo_Trace_ID">
    <vt:lpwstr>eyJub2RlMSI6eyJkc2QiOiIwMDAwMDAwMDAwMDAwMDAwIiwibG9nVGltZSI6IjIwMjUtMDQtMDRUMDQ6NDU6NTVaIiwicElEIjoyMDQ4LCJ0cmFjZUlkIjoiMUNDRDE1MjAwRTMyNDNGNjk4OTQ4Njc5QjEyMTdGMUEiLCJ1c2VyQ29kZSI6IjIzMzg4NSJ9LCJub2RlMiI6eyJkc2QiOiIwMTAwMDAwMDAwMDAzMzEzIiwibG9nVGltZSI6IjI</vt:lpwstr>
  </property>
</Properties>
</file>